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A45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5993"/>
    <p:restoredTop sz="91691" autoAdjust="0"/>
  </p:normalViewPr>
  <p:slideViewPr>
    <p:cSldViewPr snapToGrid="0" snapToObjects="1">
      <p:cViewPr varScale="1">
        <p:scale>
          <a:sx n="101" d="100"/>
          <a:sy n="101" d="100"/>
        </p:scale>
        <p:origin x="232" y="3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E5FE80-2B3D-0A48-8071-2463A82EBD9D}" type="datetimeFigureOut">
              <a:rPr lang="en-US" smtClean="0"/>
              <a:t>7/29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DE21D4-71C3-6E40-AB38-EA6473CED9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670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6DE21D4-71C3-6E40-AB38-EA6473CED93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376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B5E68-2A25-D241-B847-5A46FB125B5E}" type="datetimeFigureOut">
              <a:rPr lang="en-US" smtClean="0"/>
              <a:t>7/2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0A13-9004-A14F-B44C-A0B489C7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7553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B5E68-2A25-D241-B847-5A46FB125B5E}" type="datetimeFigureOut">
              <a:rPr lang="en-US" smtClean="0"/>
              <a:t>7/2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0A13-9004-A14F-B44C-A0B489C7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8040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B5E68-2A25-D241-B847-5A46FB125B5E}" type="datetimeFigureOut">
              <a:rPr lang="en-US" smtClean="0"/>
              <a:t>7/2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0A13-9004-A14F-B44C-A0B489C7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1850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B5E68-2A25-D241-B847-5A46FB125B5E}" type="datetimeFigureOut">
              <a:rPr lang="en-US" smtClean="0"/>
              <a:t>7/2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0A13-9004-A14F-B44C-A0B489C7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844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B5E68-2A25-D241-B847-5A46FB125B5E}" type="datetimeFigureOut">
              <a:rPr lang="en-US" smtClean="0"/>
              <a:t>7/2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0A13-9004-A14F-B44C-A0B489C7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087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B5E68-2A25-D241-B847-5A46FB125B5E}" type="datetimeFigureOut">
              <a:rPr lang="en-US" smtClean="0"/>
              <a:t>7/2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0A13-9004-A14F-B44C-A0B489C7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930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B5E68-2A25-D241-B847-5A46FB125B5E}" type="datetimeFigureOut">
              <a:rPr lang="en-US" smtClean="0"/>
              <a:t>7/29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0A13-9004-A14F-B44C-A0B489C7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471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B5E68-2A25-D241-B847-5A46FB125B5E}" type="datetimeFigureOut">
              <a:rPr lang="en-US" smtClean="0"/>
              <a:t>7/29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0A13-9004-A14F-B44C-A0B489C7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9318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B5E68-2A25-D241-B847-5A46FB125B5E}" type="datetimeFigureOut">
              <a:rPr lang="en-US" smtClean="0"/>
              <a:t>7/29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0A13-9004-A14F-B44C-A0B489C7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684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B5E68-2A25-D241-B847-5A46FB125B5E}" type="datetimeFigureOut">
              <a:rPr lang="en-US" smtClean="0"/>
              <a:t>7/2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0A13-9004-A14F-B44C-A0B489C7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080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B5E68-2A25-D241-B847-5A46FB125B5E}" type="datetimeFigureOut">
              <a:rPr lang="en-US" smtClean="0"/>
              <a:t>7/2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80A13-9004-A14F-B44C-A0B489C7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491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BB5E68-2A25-D241-B847-5A46FB125B5E}" type="datetimeFigureOut">
              <a:rPr lang="en-US" smtClean="0"/>
              <a:t>7/2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380A13-9004-A14F-B44C-A0B489C7A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3153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8" name="Straight Arrow Connector 17"/>
          <p:cNvCxnSpPr>
            <a:cxnSpLocks/>
          </p:cNvCxnSpPr>
          <p:nvPr/>
        </p:nvCxnSpPr>
        <p:spPr>
          <a:xfrm>
            <a:off x="6904248" y="4365463"/>
            <a:ext cx="65953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772404" y="2749746"/>
            <a:ext cx="1359258" cy="276999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solidFill>
              <a:schemeClr val="bg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Inflammation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772404" y="3091489"/>
            <a:ext cx="1359259" cy="276999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solidFill>
              <a:schemeClr val="bg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Oxidative Damage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772404" y="3433232"/>
            <a:ext cx="1359259" cy="276999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solidFill>
              <a:schemeClr val="bg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Apoptosis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1772404" y="4116719"/>
            <a:ext cx="1359258" cy="276999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solidFill>
              <a:schemeClr val="bg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Necrosis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1772404" y="3774975"/>
            <a:ext cx="1359258" cy="276999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solidFill>
              <a:schemeClr val="bg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arcinogenesis</a:t>
            </a:r>
          </a:p>
        </p:txBody>
      </p:sp>
      <p:sp>
        <p:nvSpPr>
          <p:cNvPr id="35" name="Oval 34"/>
          <p:cNvSpPr/>
          <p:nvPr/>
        </p:nvSpPr>
        <p:spPr>
          <a:xfrm>
            <a:off x="4371911" y="3310379"/>
            <a:ext cx="604685" cy="48699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300" dirty="0"/>
              <a:t>AFL</a:t>
            </a:r>
          </a:p>
        </p:txBody>
      </p:sp>
      <p:sp>
        <p:nvSpPr>
          <p:cNvPr id="27" name="Oval 26"/>
          <p:cNvSpPr/>
          <p:nvPr/>
        </p:nvSpPr>
        <p:spPr>
          <a:xfrm>
            <a:off x="3550368" y="4121968"/>
            <a:ext cx="787937" cy="48699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00" dirty="0"/>
              <a:t>NAFLD</a:t>
            </a:r>
          </a:p>
        </p:txBody>
      </p:sp>
      <p:sp>
        <p:nvSpPr>
          <p:cNvPr id="36" name="Oval 35"/>
          <p:cNvSpPr/>
          <p:nvPr/>
        </p:nvSpPr>
        <p:spPr>
          <a:xfrm>
            <a:off x="5240526" y="3329731"/>
            <a:ext cx="734910" cy="48699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HBV</a:t>
            </a:r>
          </a:p>
        </p:txBody>
      </p:sp>
      <p:sp>
        <p:nvSpPr>
          <p:cNvPr id="39" name="Oval 38"/>
          <p:cNvSpPr/>
          <p:nvPr/>
        </p:nvSpPr>
        <p:spPr>
          <a:xfrm>
            <a:off x="5900861" y="4154491"/>
            <a:ext cx="686584" cy="381995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300"/>
              <a:t>HCC</a:t>
            </a:r>
            <a:endParaRPr lang="en-US" sz="1300" dirty="0"/>
          </a:p>
        </p:txBody>
      </p:sp>
      <p:sp>
        <p:nvSpPr>
          <p:cNvPr id="40" name="Oval 39"/>
          <p:cNvSpPr/>
          <p:nvPr/>
        </p:nvSpPr>
        <p:spPr>
          <a:xfrm>
            <a:off x="4555618" y="4949709"/>
            <a:ext cx="620116" cy="48699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LF</a:t>
            </a:r>
          </a:p>
        </p:txBody>
      </p:sp>
      <p:sp>
        <p:nvSpPr>
          <p:cNvPr id="41" name="Oval 40"/>
          <p:cNvSpPr/>
          <p:nvPr/>
        </p:nvSpPr>
        <p:spPr>
          <a:xfrm>
            <a:off x="5343690" y="4767289"/>
            <a:ext cx="668067" cy="468421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/>
              <a:t>LC</a:t>
            </a:r>
            <a:endParaRPr lang="en-US" sz="1200" dirty="0"/>
          </a:p>
        </p:txBody>
      </p:sp>
      <p:sp>
        <p:nvSpPr>
          <p:cNvPr id="43" name="Rectangle 42"/>
          <p:cNvSpPr/>
          <p:nvPr/>
        </p:nvSpPr>
        <p:spPr>
          <a:xfrm>
            <a:off x="1614053" y="2343258"/>
            <a:ext cx="1661079" cy="3146589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TextBox 44"/>
          <p:cNvSpPr txBox="1"/>
          <p:nvPr/>
        </p:nvSpPr>
        <p:spPr>
          <a:xfrm>
            <a:off x="3642586" y="5717587"/>
            <a:ext cx="319588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Liver Disease Experimental Studies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481447" y="1264903"/>
            <a:ext cx="1521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Lycium</a:t>
            </a:r>
            <a:r>
              <a:rPr lang="en-US" sz="1200" dirty="0"/>
              <a:t> </a:t>
            </a:r>
            <a:r>
              <a:rPr lang="en-US" sz="1200" dirty="0" err="1"/>
              <a:t>barbarum</a:t>
            </a:r>
            <a:endParaRPr lang="en-US" sz="1200" dirty="0"/>
          </a:p>
        </p:txBody>
      </p:sp>
      <p:pic>
        <p:nvPicPr>
          <p:cNvPr id="48" name="Content Placeholder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2640" y="1200901"/>
            <a:ext cx="870183" cy="671497"/>
          </a:xfrm>
          <a:prstGeom prst="rect">
            <a:avLst/>
          </a:prstGeom>
        </p:spPr>
      </p:pic>
      <p:cxnSp>
        <p:nvCxnSpPr>
          <p:cNvPr id="19" name="Straight Arrow Connector 18"/>
          <p:cNvCxnSpPr>
            <a:cxnSpLocks/>
          </p:cNvCxnSpPr>
          <p:nvPr/>
        </p:nvCxnSpPr>
        <p:spPr>
          <a:xfrm>
            <a:off x="5047731" y="866273"/>
            <a:ext cx="0" cy="52709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3693741" y="650830"/>
            <a:ext cx="181262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Solvent-based Extraction </a:t>
            </a:r>
          </a:p>
          <a:p>
            <a:r>
              <a:rPr lang="en-US" sz="1100" dirty="0"/>
              <a:t>&amp; Purification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4447012" y="1896818"/>
            <a:ext cx="1695417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Zeaxanthin </a:t>
            </a:r>
            <a:r>
              <a:rPr lang="en-US" sz="1200" dirty="0" err="1"/>
              <a:t>Dipalmitate</a:t>
            </a:r>
            <a:endParaRPr lang="en-US" sz="1200" dirty="0"/>
          </a:p>
        </p:txBody>
      </p:sp>
      <p:sp>
        <p:nvSpPr>
          <p:cNvPr id="20" name="Oval 19"/>
          <p:cNvSpPr/>
          <p:nvPr/>
        </p:nvSpPr>
        <p:spPr>
          <a:xfrm>
            <a:off x="3363714" y="3011916"/>
            <a:ext cx="3540534" cy="2641176"/>
          </a:xfrm>
          <a:prstGeom prst="ellipse">
            <a:avLst/>
          </a:prstGeom>
          <a:noFill/>
          <a:ln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3" name="Straight Arrow Connector 52"/>
          <p:cNvCxnSpPr>
            <a:cxnSpLocks/>
          </p:cNvCxnSpPr>
          <p:nvPr/>
        </p:nvCxnSpPr>
        <p:spPr>
          <a:xfrm>
            <a:off x="5175734" y="2200159"/>
            <a:ext cx="0" cy="76251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5184263" y="2781295"/>
            <a:ext cx="13215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Treatment 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2711435" y="2461914"/>
            <a:ext cx="3430994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Targets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1772404" y="2408003"/>
            <a:ext cx="1359258" cy="276999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solidFill>
              <a:schemeClr val="bg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Fibrosis</a:t>
            </a:r>
          </a:p>
        </p:txBody>
      </p:sp>
      <p:pic>
        <p:nvPicPr>
          <p:cNvPr id="62" name="Picture 6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7585" y="3916553"/>
            <a:ext cx="1493357" cy="975587"/>
          </a:xfrm>
          <a:prstGeom prst="rect">
            <a:avLst/>
          </a:prstGeom>
        </p:spPr>
      </p:pic>
      <p:pic>
        <p:nvPicPr>
          <p:cNvPr id="63" name="Picture 6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96686" y="4040620"/>
            <a:ext cx="1298048" cy="851520"/>
          </a:xfrm>
          <a:prstGeom prst="rect">
            <a:avLst/>
          </a:prstGeom>
        </p:spPr>
      </p:pic>
      <p:pic>
        <p:nvPicPr>
          <p:cNvPr id="33" name="Content Placeholder 15">
            <a:extLst>
              <a:ext uri="{FF2B5EF4-FFF2-40B4-BE49-F238E27FC236}">
                <a16:creationId xmlns:a16="http://schemas.microsoft.com/office/drawing/2014/main" id="{A58DE204-6610-4015-8DA6-C2020B9377F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6"/>
          <a:srcRect l="30804" t="38865" r="34782" b="20247"/>
          <a:stretch/>
        </p:blipFill>
        <p:spPr>
          <a:xfrm>
            <a:off x="2481447" y="278369"/>
            <a:ext cx="1258723" cy="997003"/>
          </a:xfrm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0531087E-2204-48A2-B10E-790CD3C7F0DF}"/>
              </a:ext>
            </a:extLst>
          </p:cNvPr>
          <p:cNvSpPr txBox="1"/>
          <p:nvPr/>
        </p:nvSpPr>
        <p:spPr>
          <a:xfrm>
            <a:off x="1746409" y="5091023"/>
            <a:ext cx="1359258" cy="276999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solidFill>
              <a:schemeClr val="bg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Immunity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BB9995A-A9E3-45BB-9BAE-43F62D47A8E0}"/>
              </a:ext>
            </a:extLst>
          </p:cNvPr>
          <p:cNvSpPr txBox="1"/>
          <p:nvPr/>
        </p:nvSpPr>
        <p:spPr>
          <a:xfrm>
            <a:off x="1749847" y="4708406"/>
            <a:ext cx="1359258" cy="276999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solidFill>
              <a:schemeClr val="bg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ell Homeostasis</a:t>
            </a: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1414A9AD-A4A5-4FF7-B493-81758A783892}"/>
              </a:ext>
            </a:extLst>
          </p:cNvPr>
          <p:cNvCxnSpPr>
            <a:cxnSpLocks/>
          </p:cNvCxnSpPr>
          <p:nvPr/>
        </p:nvCxnSpPr>
        <p:spPr>
          <a:xfrm flipH="1">
            <a:off x="3363714" y="2735395"/>
            <a:ext cx="181202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8CD21DD2-80AF-4323-AFD0-5EC279D057DA}"/>
              </a:ext>
            </a:extLst>
          </p:cNvPr>
          <p:cNvCxnSpPr>
            <a:cxnSpLocks/>
          </p:cNvCxnSpPr>
          <p:nvPr/>
        </p:nvCxnSpPr>
        <p:spPr>
          <a:xfrm>
            <a:off x="1614053" y="4541810"/>
            <a:ext cx="1661079" cy="0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E9D3C219-CCF1-4473-B59A-4951E58E2766}"/>
              </a:ext>
            </a:extLst>
          </p:cNvPr>
          <p:cNvCxnSpPr>
            <a:cxnSpLocks/>
          </p:cNvCxnSpPr>
          <p:nvPr/>
        </p:nvCxnSpPr>
        <p:spPr>
          <a:xfrm>
            <a:off x="3740170" y="866273"/>
            <a:ext cx="130756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790728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41</TotalTime>
  <Words>31</Words>
  <Application>Microsoft Macintosh PowerPoint</Application>
  <PresentationFormat>Widescreen</PresentationFormat>
  <Paragraphs>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haji Azami, Nisma L</dc:creator>
  <cp:lastModifiedBy>Lena A</cp:lastModifiedBy>
  <cp:revision>154</cp:revision>
  <dcterms:created xsi:type="dcterms:W3CDTF">2019-07-03T14:35:41Z</dcterms:created>
  <dcterms:modified xsi:type="dcterms:W3CDTF">2019-07-30T02:03:08Z</dcterms:modified>
</cp:coreProperties>
</file>